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A0065"/>
    <a:srgbClr val="65AA00"/>
    <a:srgbClr val="004277"/>
    <a:srgbClr val="0092F7"/>
    <a:srgbClr val="296DC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 autoAdjust="0"/>
    <p:restoredTop sz="94660"/>
  </p:normalViewPr>
  <p:slideViewPr>
    <p:cSldViewPr snapToGrid="0">
      <p:cViewPr varScale="1">
        <p:scale>
          <a:sx n="77" d="100"/>
          <a:sy n="77" d="100"/>
        </p:scale>
        <p:origin x="600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1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73448" y="-3356"/>
            <a:ext cx="9530862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AU" sz="2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ospital admissions associated with dehydration in childhood kidney transplantati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99510" y="1024042"/>
            <a:ext cx="113883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Dehydration due to poor fluid intake is common and associates with fluid intake prescription and environmental and social challenges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59153" y="1890747"/>
            <a:ext cx="1161444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r>
              <a:rPr lang="en-GB" dirty="0">
                <a:solidFill>
                  <a:srgbClr val="004277"/>
                </a:solidFill>
              </a:rPr>
              <a:t> </a:t>
            </a:r>
          </a:p>
          <a:p>
            <a:pPr marL="285750" indent="-285750">
              <a:buFontTx/>
              <a:buChar char="-"/>
            </a:pPr>
            <a:endParaRPr lang="en-GB" dirty="0">
              <a:solidFill>
                <a:srgbClr val="0065AA"/>
              </a:solidFill>
            </a:endParaRPr>
          </a:p>
          <a:p>
            <a:pPr marL="285750" indent="-285750">
              <a:buFontTx/>
              <a:buChar char="-"/>
            </a:pPr>
            <a:endParaRPr lang="en-GB" dirty="0">
              <a:solidFill>
                <a:srgbClr val="0065AA"/>
              </a:solidFill>
            </a:endParaRPr>
          </a:p>
          <a:p>
            <a:pPr marL="285750" indent="-285750">
              <a:buFontTx/>
              <a:buChar char="-"/>
            </a:pPr>
            <a:endParaRPr lang="en-GB" dirty="0">
              <a:solidFill>
                <a:srgbClr val="0065AA"/>
              </a:solidFill>
            </a:endParaRPr>
          </a:p>
          <a:p>
            <a:pPr marL="285750" indent="-285750">
              <a:buFontTx/>
              <a:buChar char="-"/>
            </a:pP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e Page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93326" y="5678997"/>
            <a:ext cx="7384868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AU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hydration admissions after childhood kidney transplantation are common. The risk factors identified should prompt further study into fluid intake prescription and the hydration advice given to this population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02A2879-ECB2-60F6-38E4-639931BE2F49}"/>
              </a:ext>
            </a:extLst>
          </p:cNvPr>
          <p:cNvSpPr/>
          <p:nvPr/>
        </p:nvSpPr>
        <p:spPr>
          <a:xfrm>
            <a:off x="1196159" y="2610541"/>
            <a:ext cx="1836640" cy="783474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92 transplant recipients</a:t>
            </a: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C9B58351-24C2-A616-5CB3-B8448E2E32F9}"/>
              </a:ext>
            </a:extLst>
          </p:cNvPr>
          <p:cNvSpPr/>
          <p:nvPr/>
        </p:nvSpPr>
        <p:spPr>
          <a:xfrm>
            <a:off x="442999" y="242132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B0515FE-47B2-1866-E3D7-B7071BD044BA}"/>
              </a:ext>
            </a:extLst>
          </p:cNvPr>
          <p:cNvSpPr txBox="1"/>
          <p:nvPr/>
        </p:nvSpPr>
        <p:spPr>
          <a:xfrm>
            <a:off x="3118148" y="3325106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42% with </a:t>
            </a:r>
            <a:r>
              <a:rPr lang="en-AU" sz="2000" dirty="0">
                <a:solidFill>
                  <a:srgbClr val="65AA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ehydration      </a:t>
            </a:r>
          </a:p>
          <a:p>
            <a:pPr algn="ctr"/>
            <a:r>
              <a:rPr lang="en-AU" sz="2000" dirty="0">
                <a:solidFill>
                  <a:srgbClr val="65AA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     </a:t>
            </a:r>
            <a:endParaRPr lang="en-GB" sz="2000" dirty="0">
              <a:solidFill>
                <a:srgbClr val="65AA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87D9224-FBD7-B500-616B-36ABF6154FB7}"/>
              </a:ext>
            </a:extLst>
          </p:cNvPr>
          <p:cNvSpPr txBox="1"/>
          <p:nvPr/>
        </p:nvSpPr>
        <p:spPr>
          <a:xfrm>
            <a:off x="3302857" y="3943001"/>
            <a:ext cx="33443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20%     poor intake only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8004DF3-C8A0-B3EF-696B-44F6100EDA60}"/>
              </a:ext>
            </a:extLst>
          </p:cNvPr>
          <p:cNvSpPr txBox="1"/>
          <p:nvPr/>
        </p:nvSpPr>
        <p:spPr>
          <a:xfrm>
            <a:off x="3388267" y="4542809"/>
            <a:ext cx="31985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92F7"/>
                </a:solidFill>
              </a:rPr>
              <a:t>22%     with other illness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DC61B862-CE2B-E2E4-1B52-B12B3A0CDE5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3462" y="4523284"/>
            <a:ext cx="513284" cy="47545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D61A228-01BE-FBB8-E8CA-B80AA918077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1058" y="3328913"/>
            <a:ext cx="511200" cy="393754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EA7459C7-DCD3-B94E-B48E-D0DBFF9E22A8}"/>
              </a:ext>
            </a:extLst>
          </p:cNvPr>
          <p:cNvSpPr txBox="1"/>
          <p:nvPr/>
        </p:nvSpPr>
        <p:spPr>
          <a:xfrm>
            <a:off x="3650155" y="1902655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37A"/>
                </a:solidFill>
              </a:rPr>
              <a:t>First year post-transplant  </a:t>
            </a:r>
          </a:p>
          <a:p>
            <a:r>
              <a:rPr lang="en-GB" sz="2000" dirty="0">
                <a:solidFill>
                  <a:srgbClr val="00437A"/>
                </a:solidFill>
              </a:rPr>
              <a:t>                admission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C0608BF-779B-5471-96BC-E1767F3C6662}"/>
              </a:ext>
            </a:extLst>
          </p:cNvPr>
          <p:cNvSpPr txBox="1"/>
          <p:nvPr/>
        </p:nvSpPr>
        <p:spPr>
          <a:xfrm>
            <a:off x="3135227" y="2666144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131 total unplanned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A86F5018-515D-6E01-0D45-D9E4ABD9CE8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4318" y="2686323"/>
            <a:ext cx="380227" cy="38022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F7B677E8-B624-BEA9-8972-72EF9570C11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8327" y="3910839"/>
            <a:ext cx="504000" cy="50400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F06EB060-8EF1-0224-D5E3-2E44A4394BE6}"/>
              </a:ext>
            </a:extLst>
          </p:cNvPr>
          <p:cNvSpPr txBox="1"/>
          <p:nvPr/>
        </p:nvSpPr>
        <p:spPr>
          <a:xfrm>
            <a:off x="6321879" y="3948630"/>
            <a:ext cx="4846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chemeClr val="bg1"/>
                </a:solidFill>
              </a:rPr>
              <a:t>x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A7AC49AD-07EC-8357-456B-13462AA3F075}"/>
              </a:ext>
            </a:extLst>
          </p:cNvPr>
          <p:cNvSpPr/>
          <p:nvPr/>
        </p:nvSpPr>
        <p:spPr>
          <a:xfrm>
            <a:off x="3624267" y="2582092"/>
            <a:ext cx="3239999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A2D492A6-5BCF-115C-B24E-CA5D3567372E}"/>
              </a:ext>
            </a:extLst>
          </p:cNvPr>
          <p:cNvSpPr/>
          <p:nvPr/>
        </p:nvSpPr>
        <p:spPr>
          <a:xfrm>
            <a:off x="3624268" y="1957940"/>
            <a:ext cx="3240000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FF0713F2-C650-5B00-81DA-A5A1EAC8CE18}"/>
              </a:ext>
            </a:extLst>
          </p:cNvPr>
          <p:cNvSpPr/>
          <p:nvPr/>
        </p:nvSpPr>
        <p:spPr>
          <a:xfrm>
            <a:off x="3624267" y="3204969"/>
            <a:ext cx="3240000" cy="622800"/>
          </a:xfrm>
          <a:prstGeom prst="rect">
            <a:avLst/>
          </a:prstGeom>
          <a:noFill/>
          <a:ln w="41275">
            <a:solidFill>
              <a:srgbClr val="00427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65AA00"/>
              </a:solidFill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6450C64-1835-52B7-69FB-6BABC3BFB514}"/>
              </a:ext>
            </a:extLst>
          </p:cNvPr>
          <p:cNvSpPr/>
          <p:nvPr/>
        </p:nvSpPr>
        <p:spPr>
          <a:xfrm>
            <a:off x="3624266" y="3831636"/>
            <a:ext cx="3240000" cy="622841"/>
          </a:xfrm>
          <a:prstGeom prst="rect">
            <a:avLst/>
          </a:prstGeom>
          <a:noFill/>
          <a:ln w="41275">
            <a:solidFill>
              <a:srgbClr val="00427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AA0065"/>
              </a:solidFill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A21666A9-5688-27BC-A7A4-C60ECFE0C176}"/>
              </a:ext>
            </a:extLst>
          </p:cNvPr>
          <p:cNvSpPr/>
          <p:nvPr/>
        </p:nvSpPr>
        <p:spPr>
          <a:xfrm>
            <a:off x="3624265" y="4449591"/>
            <a:ext cx="3240000" cy="622841"/>
          </a:xfrm>
          <a:prstGeom prst="rect">
            <a:avLst/>
          </a:prstGeom>
          <a:noFill/>
          <a:ln w="41275">
            <a:solidFill>
              <a:srgbClr val="00427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19BFE4E-84B9-BC33-D332-1666A608E661}"/>
              </a:ext>
            </a:extLst>
          </p:cNvPr>
          <p:cNvSpPr txBox="1"/>
          <p:nvPr/>
        </p:nvSpPr>
        <p:spPr>
          <a:xfrm>
            <a:off x="8042239" y="2571692"/>
            <a:ext cx="43474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65AA00"/>
                </a:solidFill>
              </a:rPr>
              <a:t>↑ risk with fluid intake at discharge     </a:t>
            </a:r>
          </a:p>
          <a:p>
            <a:r>
              <a:rPr lang="en-GB" sz="2000" dirty="0">
                <a:solidFill>
                  <a:srgbClr val="65AA00"/>
                </a:solidFill>
              </a:rPr>
              <a:t>&gt;100 ml/kg/day 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679E860A-3A49-F90B-C1FF-D22E614CBE2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62386" y="2538437"/>
            <a:ext cx="850403" cy="6120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1057C56D-9D7B-B74F-E990-0D5143B7D8B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2893" y="3356639"/>
            <a:ext cx="650239" cy="622840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122F6AC2-2AC4-E7A9-01AB-A2D27C992127}"/>
              </a:ext>
            </a:extLst>
          </p:cNvPr>
          <p:cNvSpPr txBox="1"/>
          <p:nvPr/>
        </p:nvSpPr>
        <p:spPr>
          <a:xfrm>
            <a:off x="7264906" y="3445950"/>
            <a:ext cx="6252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chemeClr val="bg1"/>
                </a:solidFill>
              </a:rPr>
              <a:t>x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6BB835F-D960-1A0D-EE71-DED01FE83246}"/>
              </a:ext>
            </a:extLst>
          </p:cNvPr>
          <p:cNvSpPr txBox="1"/>
          <p:nvPr/>
        </p:nvSpPr>
        <p:spPr>
          <a:xfrm>
            <a:off x="8144538" y="3346700"/>
            <a:ext cx="466308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AA0065"/>
                </a:solidFill>
              </a:rPr>
              <a:t>↑ risk with age &gt; 12 yrs.</a:t>
            </a:r>
          </a:p>
          <a:p>
            <a:r>
              <a:rPr lang="en-GB" sz="2000" dirty="0">
                <a:solidFill>
                  <a:srgbClr val="AA0065"/>
                </a:solidFill>
              </a:rPr>
              <a:t>Median time 49 days post-transplant</a:t>
            </a:r>
          </a:p>
          <a:p>
            <a:r>
              <a:rPr lang="en-GB" sz="2000" dirty="0">
                <a:solidFill>
                  <a:srgbClr val="AA0065"/>
                </a:solidFill>
              </a:rPr>
              <a:t>Highest month = mid-summer </a:t>
            </a:r>
          </a:p>
          <a:p>
            <a:r>
              <a:rPr lang="en-GB" sz="2000" dirty="0">
                <a:solidFill>
                  <a:srgbClr val="AA0065"/>
                </a:solidFill>
              </a:rPr>
              <a:t>34% had a graft biopsy</a:t>
            </a:r>
          </a:p>
          <a:p>
            <a:pPr algn="ctr"/>
            <a:endParaRPr lang="en-GB" sz="2000" dirty="0">
              <a:solidFill>
                <a:srgbClr val="AA0065"/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9FFBE7C-01E3-85B3-29A9-DC67261D94EE}"/>
              </a:ext>
            </a:extLst>
          </p:cNvPr>
          <p:cNvSpPr txBox="1"/>
          <p:nvPr/>
        </p:nvSpPr>
        <p:spPr>
          <a:xfrm>
            <a:off x="7112064" y="1788783"/>
            <a:ext cx="524361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dirty="0">
                <a:solidFill>
                  <a:srgbClr val="004277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ch     admission considered as an outcome in multiple failure survival </a:t>
            </a:r>
            <a:r>
              <a:rPr lang="en-AU" sz="2000" dirty="0">
                <a:solidFill>
                  <a:srgbClr val="004277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odelling </a:t>
            </a:r>
            <a:endParaRPr lang="en-GB" sz="2400" dirty="0">
              <a:solidFill>
                <a:srgbClr val="004277"/>
              </a:solidFill>
            </a:endParaRP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F4450834-D26C-5E5C-6DD6-38825FD9571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0705" y="2142726"/>
            <a:ext cx="380227" cy="380227"/>
          </a:xfrm>
          <a:prstGeom prst="rect">
            <a:avLst/>
          </a:prstGeom>
        </p:spPr>
      </p:pic>
      <p:sp>
        <p:nvSpPr>
          <p:cNvPr id="57" name="Up Arrow 56">
            <a:extLst>
              <a:ext uri="{FF2B5EF4-FFF2-40B4-BE49-F238E27FC236}">
                <a16:creationId xmlns:a16="http://schemas.microsoft.com/office/drawing/2014/main" id="{E51C42DC-BE61-FF8A-AB04-1E3408257C36}"/>
              </a:ext>
            </a:extLst>
          </p:cNvPr>
          <p:cNvSpPr/>
          <p:nvPr/>
        </p:nvSpPr>
        <p:spPr>
          <a:xfrm rot="5400000">
            <a:off x="108466" y="4136976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Up Arrow 57">
            <a:extLst>
              <a:ext uri="{FF2B5EF4-FFF2-40B4-BE49-F238E27FC236}">
                <a16:creationId xmlns:a16="http://schemas.microsoft.com/office/drawing/2014/main" id="{C123009D-02D4-F779-F8D7-47870CF5D77E}"/>
              </a:ext>
            </a:extLst>
          </p:cNvPr>
          <p:cNvSpPr/>
          <p:nvPr/>
        </p:nvSpPr>
        <p:spPr>
          <a:xfrm rot="5400000">
            <a:off x="97922" y="451269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Up Arrow 58">
            <a:extLst>
              <a:ext uri="{FF2B5EF4-FFF2-40B4-BE49-F238E27FC236}">
                <a16:creationId xmlns:a16="http://schemas.microsoft.com/office/drawing/2014/main" id="{B87B61CA-C05C-456D-F48B-3C898EA0FE0E}"/>
              </a:ext>
            </a:extLst>
          </p:cNvPr>
          <p:cNvSpPr/>
          <p:nvPr/>
        </p:nvSpPr>
        <p:spPr>
          <a:xfrm rot="5400000">
            <a:off x="87701" y="487465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16FEEE9-09E7-80BF-424E-5700778ECEF7}"/>
              </a:ext>
            </a:extLst>
          </p:cNvPr>
          <p:cNvSpPr txBox="1"/>
          <p:nvPr/>
        </p:nvSpPr>
        <p:spPr>
          <a:xfrm>
            <a:off x="0" y="3772633"/>
            <a:ext cx="254174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277"/>
                </a:solidFill>
              </a:rPr>
              <a:t>Retrospective cohort </a:t>
            </a:r>
          </a:p>
          <a:p>
            <a:pPr algn="ctr"/>
            <a:endParaRPr lang="en-GB" sz="2000" dirty="0">
              <a:solidFill>
                <a:srgbClr val="00437A"/>
              </a:solidFill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98DFB2E-F108-E5B1-E2DA-57C120E2E35D}"/>
              </a:ext>
            </a:extLst>
          </p:cNvPr>
          <p:cNvSpPr txBox="1"/>
          <p:nvPr/>
        </p:nvSpPr>
        <p:spPr>
          <a:xfrm>
            <a:off x="444067" y="4146986"/>
            <a:ext cx="3150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277"/>
                </a:solidFill>
              </a:rPr>
              <a:t>2 children’s tertiary centres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730BCDF-E462-D145-C5EB-077C8445142A}"/>
              </a:ext>
            </a:extLst>
          </p:cNvPr>
          <p:cNvSpPr txBox="1"/>
          <p:nvPr/>
        </p:nvSpPr>
        <p:spPr>
          <a:xfrm>
            <a:off x="495271" y="4547476"/>
            <a:ext cx="3150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277"/>
                </a:solidFill>
              </a:rPr>
              <a:t>Victoria, Australi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4D6E722-EDFF-CF27-3B70-5FEB9258745C}"/>
              </a:ext>
            </a:extLst>
          </p:cNvPr>
          <p:cNvSpPr txBox="1"/>
          <p:nvPr/>
        </p:nvSpPr>
        <p:spPr>
          <a:xfrm>
            <a:off x="188312" y="4886223"/>
            <a:ext cx="687190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277"/>
                </a:solidFill>
              </a:rPr>
              <a:t>     Dehydration admission </a:t>
            </a:r>
          </a:p>
          <a:p>
            <a:r>
              <a:rPr lang="en-GB" sz="2000" dirty="0">
                <a:solidFill>
                  <a:srgbClr val="004277"/>
                </a:solidFill>
              </a:rPr>
              <a:t>     = ↑ creatinine, ↓ with rehydration, no direct graft damage</a:t>
            </a:r>
          </a:p>
          <a:p>
            <a:endParaRPr lang="en-GB" sz="2000" dirty="0">
              <a:solidFill>
                <a:srgbClr val="004277"/>
              </a:solidFill>
            </a:endParaRP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99474DC7-C0C6-84D0-86BA-B4BBFB3E838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8316" y="1773394"/>
            <a:ext cx="511200" cy="393754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553DFB96-9D8B-520D-03B8-835578FCAA2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1339" y="2660529"/>
            <a:ext cx="380227" cy="380227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B5C0BB41-7CF7-E19B-030A-4C57D87FD11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620" y="3478755"/>
            <a:ext cx="380227" cy="38755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C3B0A24-8F66-8BF1-F156-2E5A6EED2CF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677" y="3943921"/>
            <a:ext cx="511200" cy="39375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C62653E-64C3-C4C9-1793-166135A2D8B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9706" y="4537373"/>
            <a:ext cx="511200" cy="39375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3720AD7-F0EB-B1E5-ABC7-0BDD8DC9423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9945" y="4749608"/>
            <a:ext cx="513284" cy="47545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1EAFA2B-06B5-7970-5F21-B35AFD4931B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0256" y="4814261"/>
            <a:ext cx="380227" cy="38022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C3FC2F3-5C46-0804-6E02-B43D0A2EADC3}"/>
              </a:ext>
            </a:extLst>
          </p:cNvPr>
          <p:cNvSpPr txBox="1"/>
          <p:nvPr/>
        </p:nvSpPr>
        <p:spPr>
          <a:xfrm>
            <a:off x="8166498" y="4717919"/>
            <a:ext cx="37767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solidFill>
                  <a:srgbClr val="0092F7"/>
                </a:solidFill>
              </a:rPr>
              <a:t>↑ risk with enteric feeding tube (correlated with younger age)</a:t>
            </a:r>
            <a:endParaRPr lang="en-US" dirty="0">
              <a:solidFill>
                <a:srgbClr val="00B0F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90</TotalTime>
  <Words>186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4</cp:revision>
  <dcterms:created xsi:type="dcterms:W3CDTF">2019-06-13T12:30:18Z</dcterms:created>
  <dcterms:modified xsi:type="dcterms:W3CDTF">2023-07-11T15:58:46Z</dcterms:modified>
</cp:coreProperties>
</file>